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4049025-DEAD-4334-9422-3EDB9B13CA46}" v="59" dt="2018-06-22T22:18:44.81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414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若槻 尊" userId="b8d1b4893f5b4305" providerId="LiveId" clId="{74049025-DEAD-4334-9422-3EDB9B13CA46}"/>
    <pc:docChg chg="modSld">
      <pc:chgData name="若槻 尊" userId="b8d1b4893f5b4305" providerId="LiveId" clId="{74049025-DEAD-4334-9422-3EDB9B13CA46}" dt="2018-06-22T22:18:44.812" v="58" actId="255"/>
      <pc:docMkLst>
        <pc:docMk/>
      </pc:docMkLst>
      <pc:sldChg chg="addSp modSp">
        <pc:chgData name="若槻 尊" userId="b8d1b4893f5b4305" providerId="LiveId" clId="{74049025-DEAD-4334-9422-3EDB9B13CA46}" dt="2018-06-22T22:18:44.812" v="58" actId="255"/>
        <pc:sldMkLst>
          <pc:docMk/>
          <pc:sldMk cId="3839541253" sldId="256"/>
        </pc:sldMkLst>
        <pc:spChg chg="add mod">
          <ac:chgData name="若槻 尊" userId="b8d1b4893f5b4305" providerId="LiveId" clId="{74049025-DEAD-4334-9422-3EDB9B13CA46}" dt="2018-06-22T22:17:05.544" v="32" actId="1076"/>
          <ac:spMkLst>
            <pc:docMk/>
            <pc:sldMk cId="3839541253" sldId="256"/>
            <ac:spMk id="2" creationId="{0C07DBE1-EB01-40F2-A704-245D6816C8CB}"/>
          </ac:spMkLst>
        </pc:spChg>
        <pc:spChg chg="add mod">
          <ac:chgData name="若槻 尊" userId="b8d1b4893f5b4305" providerId="LiveId" clId="{74049025-DEAD-4334-9422-3EDB9B13CA46}" dt="2018-06-22T22:17:28.520" v="43" actId="1076"/>
          <ac:spMkLst>
            <pc:docMk/>
            <pc:sldMk cId="3839541253" sldId="256"/>
            <ac:spMk id="3" creationId="{B3160948-CE1F-4C33-802E-0D5E824CF063}"/>
          </ac:spMkLst>
        </pc:spChg>
        <pc:spChg chg="mod">
          <ac:chgData name="若槻 尊" userId="b8d1b4893f5b4305" providerId="LiveId" clId="{74049025-DEAD-4334-9422-3EDB9B13CA46}" dt="2018-06-22T22:18:44.812" v="58" actId="255"/>
          <ac:spMkLst>
            <pc:docMk/>
            <pc:sldMk cId="3839541253" sldId="256"/>
            <ac:spMk id="6" creationId="{25BAA1FA-0A2B-49E4-AC1A-EB4175A6E97F}"/>
          </ac:spMkLst>
        </pc:spChg>
        <pc:spChg chg="mod">
          <ac:chgData name="若槻 尊" userId="b8d1b4893f5b4305" providerId="LiveId" clId="{74049025-DEAD-4334-9422-3EDB9B13CA46}" dt="2018-06-22T22:18:44.812" v="58" actId="255"/>
          <ac:spMkLst>
            <pc:docMk/>
            <pc:sldMk cId="3839541253" sldId="256"/>
            <ac:spMk id="7" creationId="{95EC52DA-A995-4B97-A179-D0DF797AC67E}"/>
          </ac:spMkLst>
        </pc:spChg>
        <pc:spChg chg="mod">
          <ac:chgData name="若槻 尊" userId="b8d1b4893f5b4305" providerId="LiveId" clId="{74049025-DEAD-4334-9422-3EDB9B13CA46}" dt="2018-06-22T22:18:17.964" v="50" actId="20577"/>
          <ac:spMkLst>
            <pc:docMk/>
            <pc:sldMk cId="3839541253" sldId="256"/>
            <ac:spMk id="10" creationId="{20161A80-26EC-4CEA-89ED-39DA835FBCFA}"/>
          </ac:spMkLst>
        </pc:spChg>
        <pc:spChg chg="add mod">
          <ac:chgData name="若槻 尊" userId="b8d1b4893f5b4305" providerId="LiveId" clId="{74049025-DEAD-4334-9422-3EDB9B13CA46}" dt="2018-06-22T22:17:41.514" v="45" actId="1076"/>
          <ac:spMkLst>
            <pc:docMk/>
            <pc:sldMk cId="3839541253" sldId="256"/>
            <ac:spMk id="11" creationId="{6BAFD9F8-54A4-434F-A4D5-F9DD27F3056F}"/>
          </ac:spMkLst>
        </pc:spChg>
        <pc:spChg chg="add mod">
          <ac:chgData name="若槻 尊" userId="b8d1b4893f5b4305" providerId="LiveId" clId="{74049025-DEAD-4334-9422-3EDB9B13CA46}" dt="2018-06-22T22:17:41.514" v="45" actId="1076"/>
          <ac:spMkLst>
            <pc:docMk/>
            <pc:sldMk cId="3839541253" sldId="256"/>
            <ac:spMk id="12" creationId="{B4544AEB-1726-4BE7-B1C2-5D83520DDB98}"/>
          </ac:spMkLst>
        </pc:spChg>
      </pc:sldChg>
      <pc:sldChg chg="addSp modSp">
        <pc:chgData name="若槻 尊" userId="b8d1b4893f5b4305" providerId="LiveId" clId="{74049025-DEAD-4334-9422-3EDB9B13CA46}" dt="2018-06-22T22:18:34.126" v="56" actId="113"/>
        <pc:sldMkLst>
          <pc:docMk/>
          <pc:sldMk cId="3024762462" sldId="257"/>
        </pc:sldMkLst>
        <pc:spChg chg="mod">
          <ac:chgData name="若槻 尊" userId="b8d1b4893f5b4305" providerId="LiveId" clId="{74049025-DEAD-4334-9422-3EDB9B13CA46}" dt="2018-06-22T22:18:34.126" v="56" actId="113"/>
          <ac:spMkLst>
            <pc:docMk/>
            <pc:sldMk cId="3024762462" sldId="257"/>
            <ac:spMk id="6" creationId="{2F19C89C-D0C1-44B4-A290-54F9720E4839}"/>
          </ac:spMkLst>
        </pc:spChg>
        <pc:spChg chg="mod">
          <ac:chgData name="若槻 尊" userId="b8d1b4893f5b4305" providerId="LiveId" clId="{74049025-DEAD-4334-9422-3EDB9B13CA46}" dt="2018-06-22T22:18:34.126" v="56" actId="113"/>
          <ac:spMkLst>
            <pc:docMk/>
            <pc:sldMk cId="3024762462" sldId="257"/>
            <ac:spMk id="7" creationId="{7149AD97-D9D1-4D62-88B1-29E0DEE8577A}"/>
          </ac:spMkLst>
        </pc:spChg>
        <pc:spChg chg="add">
          <ac:chgData name="若槻 尊" userId="b8d1b4893f5b4305" providerId="LiveId" clId="{74049025-DEAD-4334-9422-3EDB9B13CA46}" dt="2018-06-22T22:17:46.195" v="46"/>
          <ac:spMkLst>
            <pc:docMk/>
            <pc:sldMk cId="3024762462" sldId="257"/>
            <ac:spMk id="8" creationId="{A59471FC-16EB-45DA-BEC6-652074507C0D}"/>
          </ac:spMkLst>
        </pc:spChg>
        <pc:spChg chg="add">
          <ac:chgData name="若槻 尊" userId="b8d1b4893f5b4305" providerId="LiveId" clId="{74049025-DEAD-4334-9422-3EDB9B13CA46}" dt="2018-06-22T22:17:46.195" v="46"/>
          <ac:spMkLst>
            <pc:docMk/>
            <pc:sldMk cId="3024762462" sldId="257"/>
            <ac:spMk id="9" creationId="{672E6791-6A63-472B-8A8E-E875ECBD96F3}"/>
          </ac:spMkLst>
        </pc:spChg>
        <pc:spChg chg="mod">
          <ac:chgData name="若槻 尊" userId="b8d1b4893f5b4305" providerId="LiveId" clId="{74049025-DEAD-4334-9422-3EDB9B13CA46}" dt="2018-06-22T22:18:23.090" v="54" actId="20577"/>
          <ac:spMkLst>
            <pc:docMk/>
            <pc:sldMk cId="3024762462" sldId="257"/>
            <ac:spMk id="11" creationId="{4477A5E4-409C-4AD5-BD8B-5121288F1535}"/>
          </ac:spMkLst>
        </pc:spChg>
        <pc:spChg chg="add mod">
          <ac:chgData name="若槻 尊" userId="b8d1b4893f5b4305" providerId="LiveId" clId="{74049025-DEAD-4334-9422-3EDB9B13CA46}" dt="2018-06-22T22:17:57.784" v="48" actId="1076"/>
          <ac:spMkLst>
            <pc:docMk/>
            <pc:sldMk cId="3024762462" sldId="257"/>
            <ac:spMk id="12" creationId="{CEC1AFE7-40EB-4DD1-800B-716CF4B23593}"/>
          </ac:spMkLst>
        </pc:spChg>
        <pc:spChg chg="add mod">
          <ac:chgData name="若槻 尊" userId="b8d1b4893f5b4305" providerId="LiveId" clId="{74049025-DEAD-4334-9422-3EDB9B13CA46}" dt="2018-06-22T22:17:57.784" v="48" actId="1076"/>
          <ac:spMkLst>
            <pc:docMk/>
            <pc:sldMk cId="3024762462" sldId="257"/>
            <ac:spMk id="13" creationId="{EF541068-D8BA-4F87-A0E3-3483B0F7484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E4DA98-9CD2-4CF7-86A9-3B864B2705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ADA692E-3CCD-4728-A85B-6B4477D896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7B11827-EBA8-4309-99F2-CE40794E30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86FF7-75C0-46FA-9DA0-B91EAC1350B9}" type="datetimeFigureOut">
              <a:rPr kumimoji="1" lang="ja-JP" altLang="en-US" smtClean="0"/>
              <a:t>2018/9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65B0A5E-4A2E-4BB9-9D20-D576514E38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195E08E-6784-42E3-92F1-A7B43010BB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1A5-9FBA-41E5-8A4E-4BFC34142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6755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590F19-EE8D-448B-A368-D909476C5A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3E345D2-47A9-41B8-B5A7-6FFA03D978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F82325F-73D5-461F-B780-C0F664A7E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86FF7-75C0-46FA-9DA0-B91EAC1350B9}" type="datetimeFigureOut">
              <a:rPr kumimoji="1" lang="ja-JP" altLang="en-US" smtClean="0"/>
              <a:t>2018/9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940AD74-E61A-4D71-88F7-D2983E78A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9F7EE87-5E4B-4161-976A-5988F0EDD7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1A5-9FBA-41E5-8A4E-4BFC34142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5521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221FF29B-CEC4-471F-95C3-30D77D8C5B2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4FB3FE7-EEF5-47CD-BCA2-1EEEA9CB64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358CA48-E989-4DC7-B4A0-2CBF1A3A7E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86FF7-75C0-46FA-9DA0-B91EAC1350B9}" type="datetimeFigureOut">
              <a:rPr kumimoji="1" lang="ja-JP" altLang="en-US" smtClean="0"/>
              <a:t>2018/9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D769FF3-C5D3-49EF-BEF6-CAA8B95DE8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6FF8A65-B904-4FC7-B37D-6E1F95F60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1A5-9FBA-41E5-8A4E-4BFC34142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6015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8E500F-3344-4DA1-A232-8DCF533466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EE96376-9BAE-4D42-9958-73ABEB8720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08BC806-E059-4CC1-BFBA-4CE7A41522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86FF7-75C0-46FA-9DA0-B91EAC1350B9}" type="datetimeFigureOut">
              <a:rPr kumimoji="1" lang="ja-JP" altLang="en-US" smtClean="0"/>
              <a:t>2018/9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588F31-CE1B-4694-AF8D-26906617E6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5F5591B-15D8-4DEB-94ED-1E45B5610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1A5-9FBA-41E5-8A4E-4BFC34142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61271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2FD92F-2EBD-4763-94FD-4D3DE8CEDB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A192204-5A60-45E0-ADB4-7470016855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14EA8C3-9E94-4D5C-A124-1B3B3405F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86FF7-75C0-46FA-9DA0-B91EAC1350B9}" type="datetimeFigureOut">
              <a:rPr kumimoji="1" lang="ja-JP" altLang="en-US" smtClean="0"/>
              <a:t>2018/9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AE77C2-0535-4BEE-9B62-7E300AAE5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99F4F20-3C5A-4991-9EAF-238F83F93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1A5-9FBA-41E5-8A4E-4BFC34142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52954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54DE0B-E671-4C4B-A129-6681DA2572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6FFB44C-8A92-4E09-A0C1-930F5BA2EB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54DDA7F-0778-41A3-92A1-B7117F16FA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749B762-E62E-4EAF-AE09-FBF05C75EB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86FF7-75C0-46FA-9DA0-B91EAC1350B9}" type="datetimeFigureOut">
              <a:rPr kumimoji="1" lang="ja-JP" altLang="en-US" smtClean="0"/>
              <a:t>2018/9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0DD113E-76C4-4104-9FF0-1880D85EE2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F781297-BE3B-40A3-A617-F812FB3BE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1A5-9FBA-41E5-8A4E-4BFC34142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3708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2CF70D-96C6-4CC2-B41F-82669DB51F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01909F0-F22E-46E0-A339-E1C5E433B4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DE5741D-2847-4659-B9C8-B327E0E397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CAA3177-03E3-4BDB-BD87-61F35E79AF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9312D56-14BC-42F9-A1F0-F65434FA5B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1D25FCF-B6B6-48F6-B18D-0048885E0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86FF7-75C0-46FA-9DA0-B91EAC1350B9}" type="datetimeFigureOut">
              <a:rPr kumimoji="1" lang="ja-JP" altLang="en-US" smtClean="0"/>
              <a:t>2018/9/2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1DB6EEA-EB7C-4437-AB98-7C0531F0D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7FFE3F5-A9F3-4C29-8A63-F8B90A4A3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1A5-9FBA-41E5-8A4E-4BFC34142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3611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5592CE-CCE5-4CEC-8CEA-285ECCA764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34D31F7-65A8-4D2E-A8C3-F582606BF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86FF7-75C0-46FA-9DA0-B91EAC1350B9}" type="datetimeFigureOut">
              <a:rPr kumimoji="1" lang="ja-JP" altLang="en-US" smtClean="0"/>
              <a:t>2018/9/2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7EEBEA6-2713-4CFE-812E-0F4C05DC9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164EA79-8B09-4528-BEFE-974E1C9BF2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1A5-9FBA-41E5-8A4E-4BFC34142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5273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F396444-FB6A-4E39-92CB-4D0B495D16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86FF7-75C0-46FA-9DA0-B91EAC1350B9}" type="datetimeFigureOut">
              <a:rPr kumimoji="1" lang="ja-JP" altLang="en-US" smtClean="0"/>
              <a:t>2018/9/2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93B560F-9BF5-43A4-B223-C06F382B0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97EDA98-3DAF-4732-BECF-C1CFCF7A2B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1A5-9FBA-41E5-8A4E-4BFC34142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0362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9E7454-8E36-43C1-B868-6EE90FCAE8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34F1B12-7AD6-4975-93A8-41D7636842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95867C4-86D3-4589-9516-AD09FDFE06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2A5CA66-8CC7-43D9-A785-2F87192BC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86FF7-75C0-46FA-9DA0-B91EAC1350B9}" type="datetimeFigureOut">
              <a:rPr kumimoji="1" lang="ja-JP" altLang="en-US" smtClean="0"/>
              <a:t>2018/9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8332EC6-66F5-4A49-AD0F-3E944F8BF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F7786C6-512D-42B0-B907-9132847BC4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1A5-9FBA-41E5-8A4E-4BFC34142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8695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390DD6-442F-4FD4-B706-FC490B449E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6DC5FD8-D261-4AC9-8EF1-C0C7781160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9B16CC7-09D3-4343-9CE7-933261CB7A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24986C4-8299-4465-BAD5-F827B3B40D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86FF7-75C0-46FA-9DA0-B91EAC1350B9}" type="datetimeFigureOut">
              <a:rPr kumimoji="1" lang="ja-JP" altLang="en-US" smtClean="0"/>
              <a:t>2018/9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1972640-0985-46DD-BEA3-1655454312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C8C4816-E951-4C97-BB5F-24A723BCA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1A5-9FBA-41E5-8A4E-4BFC34142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1295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CBF1D92-7152-4CB6-B7E3-662026E4FE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B7317B4-D920-401E-8718-473C7DC1C0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49488E7-9459-4F8B-B654-8D14772F6E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F86FF7-75C0-46FA-9DA0-B91EAC1350B9}" type="datetimeFigureOut">
              <a:rPr kumimoji="1" lang="ja-JP" altLang="en-US" smtClean="0"/>
              <a:t>2018/9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8328D3-E066-4228-A1A1-BD5B919486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3BB01EB-4A1E-4946-B24F-90D72DEA64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F311A5-9FBA-41E5-8A4E-4BFC34142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0147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8ECCBB47-5993-4A00-A5D0-1D52102CC3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1174357"/>
            <a:ext cx="5991225" cy="480060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AFE79E27-B255-4F25-8B90-0CCB49E3F2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" y="1174357"/>
            <a:ext cx="5991225" cy="48006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5BAA1FA-0A2B-49E4-AC1A-EB4175A6E97F}"/>
              </a:ext>
            </a:extLst>
          </p:cNvPr>
          <p:cNvSpPr txBox="1"/>
          <p:nvPr/>
        </p:nvSpPr>
        <p:spPr>
          <a:xfrm>
            <a:off x="3852809" y="1684962"/>
            <a:ext cx="14382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r</a:t>
            </a:r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=0.074, p=0.679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5EC52DA-A995-4B97-A179-D0DF797AC67E}"/>
              </a:ext>
            </a:extLst>
          </p:cNvPr>
          <p:cNvSpPr txBox="1"/>
          <p:nvPr/>
        </p:nvSpPr>
        <p:spPr>
          <a:xfrm>
            <a:off x="9995044" y="1684962"/>
            <a:ext cx="14382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r</a:t>
            </a:r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=0.099, p=0.481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0161A80-26EC-4CEA-89ED-39DA835FBCFA}"/>
              </a:ext>
            </a:extLst>
          </p:cNvPr>
          <p:cNvSpPr txBox="1"/>
          <p:nvPr/>
        </p:nvSpPr>
        <p:spPr>
          <a:xfrm>
            <a:off x="752559" y="590719"/>
            <a:ext cx="959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ESM 5-a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C07DBE1-EB01-40F2-A704-245D6816C8CB}"/>
              </a:ext>
            </a:extLst>
          </p:cNvPr>
          <p:cNvSpPr txBox="1"/>
          <p:nvPr/>
        </p:nvSpPr>
        <p:spPr>
          <a:xfrm>
            <a:off x="2160574" y="5821068"/>
            <a:ext cx="19892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No. of biopsy specimens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3160948-CE1F-4C33-802E-0D5E824CF063}"/>
              </a:ext>
            </a:extLst>
          </p:cNvPr>
          <p:cNvSpPr txBox="1"/>
          <p:nvPr/>
        </p:nvSpPr>
        <p:spPr>
          <a:xfrm>
            <a:off x="0" y="1440382"/>
            <a:ext cx="752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months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BAFD9F8-54A4-434F-A4D5-F9DD27F3056F}"/>
              </a:ext>
            </a:extLst>
          </p:cNvPr>
          <p:cNvSpPr txBox="1"/>
          <p:nvPr/>
        </p:nvSpPr>
        <p:spPr>
          <a:xfrm>
            <a:off x="8257268" y="5784653"/>
            <a:ext cx="19892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No. of biopsy specimens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4544AEB-1726-4BE7-B1C2-5D83520DDB98}"/>
              </a:ext>
            </a:extLst>
          </p:cNvPr>
          <p:cNvSpPr txBox="1"/>
          <p:nvPr/>
        </p:nvSpPr>
        <p:spPr>
          <a:xfrm>
            <a:off x="6096694" y="1403967"/>
            <a:ext cx="752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months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95412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859AE262-4DC7-4433-A064-E4E88222FC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1193086"/>
            <a:ext cx="5991225" cy="48006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98BEA646-CFA9-4ECA-85BD-BEF3EE3C2A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93086"/>
            <a:ext cx="5991225" cy="48006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F19C89C-D0C1-44B4-A290-54F9720E4839}"/>
              </a:ext>
            </a:extLst>
          </p:cNvPr>
          <p:cNvSpPr txBox="1"/>
          <p:nvPr/>
        </p:nvSpPr>
        <p:spPr>
          <a:xfrm>
            <a:off x="3852809" y="1684962"/>
            <a:ext cx="14927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r</a:t>
            </a:r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=-0.262, p=0.135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149AD97-D9D1-4D62-88B1-29E0DEE8577A}"/>
              </a:ext>
            </a:extLst>
          </p:cNvPr>
          <p:cNvSpPr txBox="1"/>
          <p:nvPr/>
        </p:nvSpPr>
        <p:spPr>
          <a:xfrm>
            <a:off x="9995044" y="1684962"/>
            <a:ext cx="14382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r</a:t>
            </a:r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=0.001, p=0.992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477A5E4-409C-4AD5-BD8B-5121288F1535}"/>
              </a:ext>
            </a:extLst>
          </p:cNvPr>
          <p:cNvSpPr txBox="1"/>
          <p:nvPr/>
        </p:nvSpPr>
        <p:spPr>
          <a:xfrm>
            <a:off x="752559" y="590719"/>
            <a:ext cx="969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ESM 5-b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59471FC-16EB-45DA-BEC6-652074507C0D}"/>
              </a:ext>
            </a:extLst>
          </p:cNvPr>
          <p:cNvSpPr txBox="1"/>
          <p:nvPr/>
        </p:nvSpPr>
        <p:spPr>
          <a:xfrm>
            <a:off x="2160574" y="5821068"/>
            <a:ext cx="19892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No. of biopsy specimens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72E6791-6A63-472B-8A8E-E875ECBD96F3}"/>
              </a:ext>
            </a:extLst>
          </p:cNvPr>
          <p:cNvSpPr txBox="1"/>
          <p:nvPr/>
        </p:nvSpPr>
        <p:spPr>
          <a:xfrm>
            <a:off x="0" y="1440382"/>
            <a:ext cx="752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months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EC1AFE7-40EB-4DD1-800B-716CF4B23593}"/>
              </a:ext>
            </a:extLst>
          </p:cNvPr>
          <p:cNvSpPr txBox="1"/>
          <p:nvPr/>
        </p:nvSpPr>
        <p:spPr>
          <a:xfrm>
            <a:off x="8224825" y="5821068"/>
            <a:ext cx="19892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No. of biopsy specimens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F541068-D8BA-4F87-A0E3-3483B0F7484C}"/>
              </a:ext>
            </a:extLst>
          </p:cNvPr>
          <p:cNvSpPr txBox="1"/>
          <p:nvPr/>
        </p:nvSpPr>
        <p:spPr>
          <a:xfrm>
            <a:off x="6064251" y="1440382"/>
            <a:ext cx="752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months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4762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56</Words>
  <Application>Microsoft Office PowerPoint</Application>
  <PresentationFormat>ワイド画面</PresentationFormat>
  <Paragraphs>1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若槻 尊</dc:creator>
  <cp:lastModifiedBy>八木 秀祐</cp:lastModifiedBy>
  <cp:revision>7</cp:revision>
  <dcterms:created xsi:type="dcterms:W3CDTF">2018-06-22T20:39:02Z</dcterms:created>
  <dcterms:modified xsi:type="dcterms:W3CDTF">2018-09-23T07:16:04Z</dcterms:modified>
</cp:coreProperties>
</file>